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6" r:id="rId3"/>
    <p:sldId id="262" r:id="rId4"/>
    <p:sldId id="263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6" d="100"/>
          <a:sy n="56" d="100"/>
        </p:scale>
        <p:origin x="1336" y="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9/09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9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6115362"/>
            <a:ext cx="799288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Jalleh</a:t>
            </a:r>
            <a:r>
              <a:rPr lang="en-GB" dirty="0"/>
              <a:t> et al (2022) Diabetologia DOI 10.1007/s00125-022-05796-1 </a:t>
            </a:r>
          </a:p>
          <a:p>
            <a:r>
              <a:rPr lang="en-GB" sz="1200" dirty="0">
                <a:effectLst/>
                <a:ea typeface="Times New Roman" panose="02020603050405020304" pitchFamily="18" charset="0"/>
              </a:rPr>
              <a:t>Adapted from Jones et al [8]. </a:t>
            </a:r>
            <a:r>
              <a:rPr lang="en-GB" sz="1200" dirty="0"/>
              <a:t>© SNMMI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ea typeface="Times New Roman" panose="02020603050405020304" pitchFamily="18" charset="0"/>
              </a:rPr>
              <a:t>Gastric emptying of solid and liquid nutrients in participants with long-standing type 1 or type 2 diabetes and healthy control participants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BAFB1A0-2777-22CC-BB0D-2A3C8601807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512" y="1227466"/>
            <a:ext cx="7954148" cy="44030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6074712"/>
            <a:ext cx="68407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Jalleh</a:t>
            </a:r>
            <a:r>
              <a:rPr lang="en-GB" dirty="0"/>
              <a:t> et al (2022) Diabetologia DOI 10.1007/s00125-022-05796-1 </a:t>
            </a:r>
          </a:p>
          <a:p>
            <a:r>
              <a:rPr lang="en-GB" sz="1200" dirty="0">
                <a:effectLst/>
                <a:ea typeface="Times New Roman" panose="02020603050405020304" pitchFamily="18" charset="0"/>
              </a:rPr>
              <a:t>Adapted from Watson et al [4] by permission of Oxford University Press on behalf of the Endocrine Society. </a:t>
            </a:r>
            <a:r>
              <a:rPr lang="en-GB" sz="1200" dirty="0"/>
              <a:t>© The Endocrine Society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5452" y="217887"/>
            <a:ext cx="87129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ea typeface="Times New Roman" panose="02020603050405020304" pitchFamily="18" charset="0"/>
              </a:rPr>
              <a:t>Gastric emptying of a mashed potato meal in people with type 2 diabetes, and in young and older control participants without diabetes, as assessed by </a:t>
            </a:r>
            <a:r>
              <a:rPr lang="en-GB" sz="1800" b="1" baseline="30000" dirty="0">
                <a:effectLst/>
                <a:ea typeface="Times New Roman" panose="02020603050405020304" pitchFamily="18" charset="0"/>
              </a:rPr>
              <a:t>13</a:t>
            </a:r>
            <a:r>
              <a:rPr lang="en-GB" sz="1800" b="1" dirty="0">
                <a:effectLst/>
                <a:ea typeface="Times New Roman" panose="02020603050405020304" pitchFamily="18" charset="0"/>
              </a:rPr>
              <a:t>C-octanoic acid breath test 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876C432-B5A5-2646-0CF1-E77B280DD4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7664" y="1196172"/>
            <a:ext cx="5721185" cy="4588328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6074712"/>
            <a:ext cx="698477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 err="1"/>
              <a:t>Jalleh</a:t>
            </a:r>
            <a:r>
              <a:rPr lang="en-GB" sz="1800" dirty="0"/>
              <a:t> et al (2022) Diabetologia DOI 10.1007/s00125-022-05796-1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2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41279" y="246777"/>
            <a:ext cx="82089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ea typeface="Times New Roman" panose="02020603050405020304" pitchFamily="18" charset="0"/>
              </a:rPr>
              <a:t>Schema of the interdependent relationships of gastric emptying, incretin hormones and blood glucose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B54DB56-D797-EC86-E20A-93AF32BCF9B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51355" y="993687"/>
            <a:ext cx="5484941" cy="49555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A6417A6-552F-0440-7BCE-EA26F20F06AC}"/>
              </a:ext>
            </a:extLst>
          </p:cNvPr>
          <p:cNvSpPr txBox="1"/>
          <p:nvPr/>
        </p:nvSpPr>
        <p:spPr>
          <a:xfrm>
            <a:off x="179512" y="6074712"/>
            <a:ext cx="7948112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Jalleh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2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2-05796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2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4431309E-10EE-80C6-8DCF-12F2F922FA38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A0C1D46-68A0-7C23-982F-3325FFE720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4343" y="1084064"/>
            <a:ext cx="7236296" cy="436116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E9990CF-1051-C4F9-6D27-579534CAA519}"/>
              </a:ext>
            </a:extLst>
          </p:cNvPr>
          <p:cNvSpPr txBox="1"/>
          <p:nvPr/>
        </p:nvSpPr>
        <p:spPr>
          <a:xfrm>
            <a:off x="755576" y="287425"/>
            <a:ext cx="676875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effectLst/>
                <a:ea typeface="Times New Roman" panose="02020603050405020304" pitchFamily="18" charset="0"/>
              </a:rPr>
              <a:t>Recommended management of suspected diabetic gastroparesis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4102388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0</Words>
  <Application>Microsoft Office PowerPoint</Application>
  <PresentationFormat>On-screen Show (4:3)</PresentationFormat>
  <Paragraphs>13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4</cp:revision>
  <dcterms:created xsi:type="dcterms:W3CDTF">2016-06-15T12:53:43Z</dcterms:created>
  <dcterms:modified xsi:type="dcterms:W3CDTF">2022-09-29T08:16:50Z</dcterms:modified>
</cp:coreProperties>
</file>